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70" r:id="rId2"/>
  </p:sldIdLst>
  <p:sldSz cx="27432000" cy="20574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F2C1E05-47FB-4407-B222-4C42F04069EE}" v="68" dt="2021-07-19T23:01:28.69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21" d="100"/>
          <a:sy n="21" d="100"/>
        </p:scale>
        <p:origin x="133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takao shun" userId="01825ee65df99981" providerId="LiveId" clId="{EF2C1E05-47FB-4407-B222-4C42F04069EE}"/>
    <pc:docChg chg="undo custSel addSld modSld sldOrd">
      <pc:chgData name="takao shun" userId="01825ee65df99981" providerId="LiveId" clId="{EF2C1E05-47FB-4407-B222-4C42F04069EE}" dt="2021-07-20T23:51:48.916" v="2037" actId="207"/>
      <pc:docMkLst>
        <pc:docMk/>
      </pc:docMkLst>
      <pc:sldChg chg="addSp delSp modSp">
        <pc:chgData name="takao shun" userId="01825ee65df99981" providerId="LiveId" clId="{EF2C1E05-47FB-4407-B222-4C42F04069EE}" dt="2021-07-17T08:23:46.424" v="112" actId="338"/>
        <pc:sldMkLst>
          <pc:docMk/>
          <pc:sldMk cId="920535111" sldId="265"/>
        </pc:sldMkLst>
        <pc:spChg chg="mod topLvl">
          <ac:chgData name="takao shun" userId="01825ee65df99981" providerId="LiveId" clId="{EF2C1E05-47FB-4407-B222-4C42F04069EE}" dt="2021-07-17T08:23:46.424" v="112" actId="338"/>
          <ac:spMkLst>
            <pc:docMk/>
            <pc:sldMk cId="920535111" sldId="265"/>
            <ac:spMk id="100" creationId="{99B4F0B1-1D2B-4517-B661-F280A807E15E}"/>
          </ac:spMkLst>
        </pc:spChg>
        <pc:spChg chg="mod topLvl">
          <ac:chgData name="takao shun" userId="01825ee65df99981" providerId="LiveId" clId="{EF2C1E05-47FB-4407-B222-4C42F04069EE}" dt="2021-07-17T08:23:46.424" v="112" actId="338"/>
          <ac:spMkLst>
            <pc:docMk/>
            <pc:sldMk cId="920535111" sldId="265"/>
            <ac:spMk id="102" creationId="{C474FC7D-9961-475B-B742-04C42D0B69F6}"/>
          </ac:spMkLst>
        </pc:spChg>
        <pc:spChg chg="mod topLvl">
          <ac:chgData name="takao shun" userId="01825ee65df99981" providerId="LiveId" clId="{EF2C1E05-47FB-4407-B222-4C42F04069EE}" dt="2021-07-17T08:23:46.424" v="112" actId="338"/>
          <ac:spMkLst>
            <pc:docMk/>
            <pc:sldMk cId="920535111" sldId="265"/>
            <ac:spMk id="104" creationId="{DEDB27E7-E65B-47AD-839E-1F444438D064}"/>
          </ac:spMkLst>
        </pc:spChg>
        <pc:grpChg chg="add mod">
          <ac:chgData name="takao shun" userId="01825ee65df99981" providerId="LiveId" clId="{EF2C1E05-47FB-4407-B222-4C42F04069EE}" dt="2021-07-17T08:23:46.424" v="112" actId="338"/>
          <ac:grpSpMkLst>
            <pc:docMk/>
            <pc:sldMk cId="920535111" sldId="265"/>
            <ac:grpSpMk id="2" creationId="{315573CC-5013-4ED5-891C-FF5E9EDC3461}"/>
          </ac:grpSpMkLst>
        </pc:grpChg>
        <pc:grpChg chg="del">
          <ac:chgData name="takao shun" userId="01825ee65df99981" providerId="LiveId" clId="{EF2C1E05-47FB-4407-B222-4C42F04069EE}" dt="2021-07-17T08:23:36.726" v="111" actId="165"/>
          <ac:grpSpMkLst>
            <pc:docMk/>
            <pc:sldMk cId="920535111" sldId="265"/>
            <ac:grpSpMk id="99" creationId="{D8CEBADA-044D-4EE9-AEBA-E1C3C9F03CE5}"/>
          </ac:grpSpMkLst>
        </pc:grpChg>
        <pc:cxnChg chg="mod topLvl">
          <ac:chgData name="takao shun" userId="01825ee65df99981" providerId="LiveId" clId="{EF2C1E05-47FB-4407-B222-4C42F04069EE}" dt="2021-07-17T08:23:46.424" v="112" actId="338"/>
          <ac:cxnSpMkLst>
            <pc:docMk/>
            <pc:sldMk cId="920535111" sldId="265"/>
            <ac:cxnSpMk id="101" creationId="{A8BB20D2-A244-4A5E-846C-DEC8A0D54964}"/>
          </ac:cxnSpMkLst>
        </pc:cxnChg>
        <pc:cxnChg chg="mod topLvl">
          <ac:chgData name="takao shun" userId="01825ee65df99981" providerId="LiveId" clId="{EF2C1E05-47FB-4407-B222-4C42F04069EE}" dt="2021-07-17T08:23:46.424" v="112" actId="338"/>
          <ac:cxnSpMkLst>
            <pc:docMk/>
            <pc:sldMk cId="920535111" sldId="265"/>
            <ac:cxnSpMk id="103" creationId="{329283DA-2390-4EC1-8F7B-029624CA228F}"/>
          </ac:cxnSpMkLst>
        </pc:cxnChg>
      </pc:sldChg>
      <pc:sldChg chg="addSp delSp modSp mod ord">
        <pc:chgData name="takao shun" userId="01825ee65df99981" providerId="LiveId" clId="{EF2C1E05-47FB-4407-B222-4C42F04069EE}" dt="2021-07-18T08:05:43.751" v="1917" actId="20577"/>
        <pc:sldMkLst>
          <pc:docMk/>
          <pc:sldMk cId="688630229" sldId="267"/>
        </pc:sldMkLst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6" creationId="{0E16BFCA-2CBD-45B0-82CF-4704B89696B2}"/>
          </ac:spMkLst>
        </pc:spChg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7" creationId="{8F904709-3407-4B48-A30C-3211B3F8B401}"/>
          </ac:spMkLst>
        </pc:spChg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8" creationId="{3407FF43-FA5E-425C-9654-E78BDCFF30C3}"/>
          </ac:spMkLst>
        </pc:spChg>
        <pc:spChg chg="mod topLvl">
          <ac:chgData name="takao shun" userId="01825ee65df99981" providerId="LiveId" clId="{EF2C1E05-47FB-4407-B222-4C42F04069EE}" dt="2021-07-18T08:02:56.089" v="1904" actId="338"/>
          <ac:spMkLst>
            <pc:docMk/>
            <pc:sldMk cId="688630229" sldId="267"/>
            <ac:spMk id="9" creationId="{402A8B3C-B847-46F3-8455-A4720871FCB0}"/>
          </ac:spMkLst>
        </pc:spChg>
        <pc:spChg chg="mod">
          <ac:chgData name="takao shun" userId="01825ee65df99981" providerId="LiveId" clId="{EF2C1E05-47FB-4407-B222-4C42F04069EE}" dt="2021-07-18T08:02:48.235" v="1903" actId="165"/>
          <ac:spMkLst>
            <pc:docMk/>
            <pc:sldMk cId="688630229" sldId="267"/>
            <ac:spMk id="15" creationId="{4554D333-4C11-4DDF-9521-82409EDA9444}"/>
          </ac:spMkLst>
        </pc:spChg>
        <pc:spChg chg="mod">
          <ac:chgData name="takao shun" userId="01825ee65df99981" providerId="LiveId" clId="{EF2C1E05-47FB-4407-B222-4C42F04069EE}" dt="2021-07-18T08:02:48.235" v="1903" actId="165"/>
          <ac:spMkLst>
            <pc:docMk/>
            <pc:sldMk cId="688630229" sldId="267"/>
            <ac:spMk id="19" creationId="{25EBC507-68E3-410D-9F1F-28F907C8501F}"/>
          </ac:spMkLst>
        </pc:spChg>
        <pc:spChg chg="mod">
          <ac:chgData name="takao shun" userId="01825ee65df99981" providerId="LiveId" clId="{EF2C1E05-47FB-4407-B222-4C42F04069EE}" dt="2021-07-18T08:05:43.751" v="1917" actId="20577"/>
          <ac:spMkLst>
            <pc:docMk/>
            <pc:sldMk cId="688630229" sldId="267"/>
            <ac:spMk id="20" creationId="{3A694FA3-08AA-435E-8916-C209FB7765CB}"/>
          </ac:spMkLst>
        </pc:spChg>
        <pc:grpChg chg="add del mod">
          <ac:chgData name="takao shun" userId="01825ee65df99981" providerId="LiveId" clId="{EF2C1E05-47FB-4407-B222-4C42F04069EE}" dt="2021-07-18T08:02:48.235" v="1903" actId="165"/>
          <ac:grpSpMkLst>
            <pc:docMk/>
            <pc:sldMk cId="688630229" sldId="267"/>
            <ac:grpSpMk id="2" creationId="{B2094417-03FC-4879-BBCA-65D8FEE1858B}"/>
          </ac:grpSpMkLst>
        </pc:grpChg>
        <pc:grpChg chg="del mod">
          <ac:chgData name="takao shun" userId="01825ee65df99981" providerId="LiveId" clId="{EF2C1E05-47FB-4407-B222-4C42F04069EE}" dt="2021-07-18T05:25:18.009" v="1573" actId="165"/>
          <ac:grpSpMkLst>
            <pc:docMk/>
            <pc:sldMk cId="688630229" sldId="267"/>
            <ac:grpSpMk id="3" creationId="{CB201B7D-7060-49FB-BA50-AAF031143E5B}"/>
          </ac:grpSpMkLst>
        </pc:grpChg>
        <pc:grpChg chg="add mod">
          <ac:chgData name="takao shun" userId="01825ee65df99981" providerId="LiveId" clId="{EF2C1E05-47FB-4407-B222-4C42F04069EE}" dt="2021-07-18T08:02:56.089" v="1904" actId="338"/>
          <ac:grpSpMkLst>
            <pc:docMk/>
            <pc:sldMk cId="688630229" sldId="267"/>
            <ac:grpSpMk id="4" creationId="{5A865678-1C04-478A-9E39-37BF31FED27A}"/>
          </ac:grpSpMkLst>
        </pc:grpChg>
        <pc:grpChg chg="mod topLvl">
          <ac:chgData name="takao shun" userId="01825ee65df99981" providerId="LiveId" clId="{EF2C1E05-47FB-4407-B222-4C42F04069EE}" dt="2021-07-18T08:02:56.089" v="1904" actId="338"/>
          <ac:grpSpMkLst>
            <pc:docMk/>
            <pc:sldMk cId="688630229" sldId="267"/>
            <ac:grpSpMk id="10" creationId="{09BE4F2C-BABB-4E07-B371-472FE00969B1}"/>
          </ac:grpSpMkLst>
        </pc:grpChg>
        <pc:grpChg chg="mod topLvl">
          <ac:chgData name="takao shun" userId="01825ee65df99981" providerId="LiveId" clId="{EF2C1E05-47FB-4407-B222-4C42F04069EE}" dt="2021-07-18T08:02:56.089" v="1904" actId="338"/>
          <ac:grpSpMkLst>
            <pc:docMk/>
            <pc:sldMk cId="688630229" sldId="267"/>
            <ac:grpSpMk id="11" creationId="{DE3843C9-CF05-4A23-8D72-E1A0F0D23612}"/>
          </ac:grpSpMkLst>
        </pc:grpChg>
        <pc:picChg chg="mod topLvl">
          <ac:chgData name="takao shun" userId="01825ee65df99981" providerId="LiveId" clId="{EF2C1E05-47FB-4407-B222-4C42F04069EE}" dt="2021-07-18T08:02:56.089" v="1904" actId="338"/>
          <ac:picMkLst>
            <pc:docMk/>
            <pc:sldMk cId="688630229" sldId="267"/>
            <ac:picMk id="5" creationId="{77172823-9A2F-4C3A-859B-8740DC8187CD}"/>
          </ac:picMkLst>
        </pc:pic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2" creationId="{5CB7BE8D-718F-449F-9AD5-A220FC5AAE10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3" creationId="{D3DE69C1-AD10-45D0-B310-AE82C75FAD63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4" creationId="{B80B42C5-2D81-4810-B66C-8D630D25B73A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6" creationId="{B00A27DF-1360-4CAD-8735-6F1F87A3D2F3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7" creationId="{020B5886-D92C-4E67-B2B4-6A250C53BCC4}"/>
          </ac:cxnSpMkLst>
        </pc:cxnChg>
        <pc:cxnChg chg="mod">
          <ac:chgData name="takao shun" userId="01825ee65df99981" providerId="LiveId" clId="{EF2C1E05-47FB-4407-B222-4C42F04069EE}" dt="2021-07-18T08:02:48.235" v="1903" actId="165"/>
          <ac:cxnSpMkLst>
            <pc:docMk/>
            <pc:sldMk cId="688630229" sldId="267"/>
            <ac:cxnSpMk id="18" creationId="{1B6862DA-3C64-421C-B3D2-162EFB9B7B93}"/>
          </ac:cxnSpMkLst>
        </pc:cxnChg>
      </pc:sldChg>
      <pc:sldChg chg="modSp mod ord">
        <pc:chgData name="takao shun" userId="01825ee65df99981" providerId="LiveId" clId="{EF2C1E05-47FB-4407-B222-4C42F04069EE}" dt="2021-07-18T08:06:04.224" v="1921" actId="20577"/>
        <pc:sldMkLst>
          <pc:docMk/>
          <pc:sldMk cId="1746615181" sldId="268"/>
        </pc:sldMkLst>
        <pc:spChg chg="mod">
          <ac:chgData name="takao shun" userId="01825ee65df99981" providerId="LiveId" clId="{EF2C1E05-47FB-4407-B222-4C42F04069EE}" dt="2021-07-18T08:06:04.224" v="1921" actId="20577"/>
          <ac:spMkLst>
            <pc:docMk/>
            <pc:sldMk cId="1746615181" sldId="268"/>
            <ac:spMk id="14" creationId="{3A694FA3-08AA-435E-8916-C209FB7765CB}"/>
          </ac:spMkLst>
        </pc:spChg>
      </pc:sldChg>
      <pc:sldChg chg="modSp mod">
        <pc:chgData name="takao shun" userId="01825ee65df99981" providerId="LiveId" clId="{EF2C1E05-47FB-4407-B222-4C42F04069EE}" dt="2021-07-18T08:00:28.826" v="1902" actId="14100"/>
        <pc:sldMkLst>
          <pc:docMk/>
          <pc:sldMk cId="4226410676" sldId="269"/>
        </pc:sldMkLst>
        <pc:spChg chg="mod">
          <ac:chgData name="takao shun" userId="01825ee65df99981" providerId="LiveId" clId="{EF2C1E05-47FB-4407-B222-4C42F04069EE}" dt="2021-07-18T08:00:28.826" v="1902" actId="14100"/>
          <ac:spMkLst>
            <pc:docMk/>
            <pc:sldMk cId="4226410676" sldId="269"/>
            <ac:spMk id="9" creationId="{3A694FA3-08AA-435E-8916-C209FB7765CB}"/>
          </ac:spMkLst>
        </pc:spChg>
      </pc:sldChg>
      <pc:sldChg chg="addSp delSp modSp new mod ord">
        <pc:chgData name="takao shun" userId="01825ee65df99981" providerId="LiveId" clId="{EF2C1E05-47FB-4407-B222-4C42F04069EE}" dt="2021-07-20T23:51:45.876" v="2036" actId="207"/>
        <pc:sldMkLst>
          <pc:docMk/>
          <pc:sldMk cId="3480027898" sldId="270"/>
        </pc:sldMkLst>
        <pc:spChg chg="del">
          <ac:chgData name="takao shun" userId="01825ee65df99981" providerId="LiveId" clId="{EF2C1E05-47FB-4407-B222-4C42F04069EE}" dt="2021-07-16T14:30:24.883" v="2" actId="478"/>
          <ac:spMkLst>
            <pc:docMk/>
            <pc:sldMk cId="3480027898" sldId="270"/>
            <ac:spMk id="2" creationId="{C0DEE832-E1F8-4F04-A61F-ED513DC6449E}"/>
          </ac:spMkLst>
        </pc:spChg>
        <pc:spChg chg="del">
          <ac:chgData name="takao shun" userId="01825ee65df99981" providerId="LiveId" clId="{EF2C1E05-47FB-4407-B222-4C42F04069EE}" dt="2021-07-16T14:30:23.894" v="1" actId="478"/>
          <ac:spMkLst>
            <pc:docMk/>
            <pc:sldMk cId="3480027898" sldId="270"/>
            <ac:spMk id="3" creationId="{5E14524D-66FA-4CB9-A557-4D1D0C5AA13A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6" creationId="{531812AD-403E-4B88-A079-DAC5897A9C16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7" creationId="{55B08221-F6CA-4925-AC98-DD828770AD91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8" creationId="{8E17DB80-20AE-4935-8F8E-708986699F9A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9" creationId="{39B6C719-1FEF-43E9-ABD5-437A123DF927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10" creationId="{18223EEB-4ABF-4CAE-86F4-F5DDD5D8673E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11" creationId="{67E250A5-5B4F-4C7F-A8FB-56C4D8C87BB8}"/>
          </ac:spMkLst>
        </pc:spChg>
        <pc:spChg chg="mod topLvl">
          <ac:chgData name="takao shun" userId="01825ee65df99981" providerId="LiveId" clId="{EF2C1E05-47FB-4407-B222-4C42F04069EE}" dt="2021-07-18T07:16:15.351" v="1875" actId="338"/>
          <ac:spMkLst>
            <pc:docMk/>
            <pc:sldMk cId="3480027898" sldId="270"/>
            <ac:spMk id="12" creationId="{86868505-CAE5-4224-A344-4511AEA638AC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6" creationId="{314712D7-CE11-4F88-A30E-98B913536C2D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7" creationId="{22A4E2C9-0863-4544-97F0-2EACC584FAA7}"/>
          </ac:spMkLst>
        </pc:spChg>
        <pc:spChg chg="mod topLvl">
          <ac:chgData name="takao shun" userId="01825ee65df99981" providerId="LiveId" clId="{EF2C1E05-47FB-4407-B222-4C42F04069EE}" dt="2021-07-18T05:27:58.541" v="1785" actId="1035"/>
          <ac:spMkLst>
            <pc:docMk/>
            <pc:sldMk cId="3480027898" sldId="270"/>
            <ac:spMk id="17" creationId="{CA6FCC92-CBE0-4BF3-9E9F-28950D74D92E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8" creationId="{22E44D19-3C4F-408E-8BFF-10ADD9EE9B95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19" creationId="{E81A05F7-EBB1-4C12-A665-AB7DB10957A8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0" creationId="{468E8ADE-468F-4B9A-A294-7D08394B810D}"/>
          </ac:spMkLst>
        </pc:spChg>
        <pc:spChg chg="add mod">
          <ac:chgData name="takao shun" userId="01825ee65df99981" providerId="LiveId" clId="{EF2C1E05-47FB-4407-B222-4C42F04069EE}" dt="2021-07-20T23:51:45.876" v="2036" actId="207"/>
          <ac:spMkLst>
            <pc:docMk/>
            <pc:sldMk cId="3480027898" sldId="270"/>
            <ac:spMk id="20" creationId="{C8192A9C-9C47-404A-A097-D7CD86FBDC70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1" creationId="{3830E321-EB2E-493B-8115-5284589C3E4D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2" creationId="{10EA10AC-7234-40FF-B320-DC1E050EBDDF}"/>
          </ac:spMkLst>
        </pc:spChg>
        <pc:spChg chg="mod">
          <ac:chgData name="takao shun" userId="01825ee65df99981" providerId="LiveId" clId="{EF2C1E05-47FB-4407-B222-4C42F04069EE}" dt="2021-07-16T14:30:26.390" v="3"/>
          <ac:spMkLst>
            <pc:docMk/>
            <pc:sldMk cId="3480027898" sldId="270"/>
            <ac:spMk id="23" creationId="{0E988EB2-43EE-4AFD-B242-93091009A6CD}"/>
          </ac:spMkLst>
        </pc:spChg>
        <pc:grpChg chg="add del mod">
          <ac:chgData name="takao shun" userId="01825ee65df99981" providerId="LiveId" clId="{EF2C1E05-47FB-4407-B222-4C42F04069EE}" dt="2021-07-18T05:28:41.578" v="1797" actId="478"/>
          <ac:grpSpMkLst>
            <pc:docMk/>
            <pc:sldMk cId="3480027898" sldId="270"/>
            <ac:grpSpMk id="3" creationId="{3C2D483B-B901-4A35-A22E-E9CD17A0DE32}"/>
          </ac:grpSpMkLst>
        </pc:grpChg>
        <pc:grpChg chg="add del mod">
          <ac:chgData name="takao shun" userId="01825ee65df99981" providerId="LiveId" clId="{EF2C1E05-47FB-4407-B222-4C42F04069EE}" dt="2021-07-18T07:15:47.408" v="1851" actId="165"/>
          <ac:grpSpMkLst>
            <pc:docMk/>
            <pc:sldMk cId="3480027898" sldId="270"/>
            <ac:grpSpMk id="4" creationId="{8F0B5D48-80F6-4497-AA37-2B4932CDBF13}"/>
          </ac:grpSpMkLst>
        </pc:grpChg>
        <pc:grpChg chg="add del mod">
          <ac:chgData name="takao shun" userId="01825ee65df99981" providerId="LiveId" clId="{EF2C1E05-47FB-4407-B222-4C42F04069EE}" dt="2021-07-18T05:26:43.610" v="1644" actId="165"/>
          <ac:grpSpMkLst>
            <pc:docMk/>
            <pc:sldMk cId="3480027898" sldId="270"/>
            <ac:grpSpMk id="13" creationId="{ADC53374-793F-4771-9554-F2D5F4161D86}"/>
          </ac:grpSpMkLst>
        </pc:grpChg>
        <pc:grpChg chg="add del mod">
          <ac:chgData name="takao shun" userId="01825ee65df99981" providerId="LiveId" clId="{EF2C1E05-47FB-4407-B222-4C42F04069EE}" dt="2021-07-16T14:31:57.394" v="14" actId="21"/>
          <ac:grpSpMkLst>
            <pc:docMk/>
            <pc:sldMk cId="3480027898" sldId="270"/>
            <ac:grpSpMk id="13" creationId="{FF2341B2-0F42-4396-BF38-C6A56F902061}"/>
          </ac:grpSpMkLst>
        </pc:grpChg>
        <pc:grpChg chg="add mod">
          <ac:chgData name="takao shun" userId="01825ee65df99981" providerId="LiveId" clId="{EF2C1E05-47FB-4407-B222-4C42F04069EE}" dt="2021-07-18T07:16:15.351" v="1875" actId="338"/>
          <ac:grpSpMkLst>
            <pc:docMk/>
            <pc:sldMk cId="3480027898" sldId="270"/>
            <ac:grpSpMk id="19" creationId="{1D00C355-8D93-4D60-944D-2ECB908A96A2}"/>
          </ac:grpSpMkLst>
        </pc:grpChg>
        <pc:picChg chg="mod topLvl">
          <ac:chgData name="takao shun" userId="01825ee65df99981" providerId="LiveId" clId="{EF2C1E05-47FB-4407-B222-4C42F04069EE}" dt="2021-07-18T07:16:15.351" v="1875" actId="338"/>
          <ac:picMkLst>
            <pc:docMk/>
            <pc:sldMk cId="3480027898" sldId="270"/>
            <ac:picMk id="5" creationId="{05A0B8BB-75F4-49E1-9EE8-B6180A3AF4E4}"/>
          </ac:picMkLst>
        </pc:picChg>
        <pc:picChg chg="mod">
          <ac:chgData name="takao shun" userId="01825ee65df99981" providerId="LiveId" clId="{EF2C1E05-47FB-4407-B222-4C42F04069EE}" dt="2021-07-16T14:30:26.390" v="3"/>
          <ac:picMkLst>
            <pc:docMk/>
            <pc:sldMk cId="3480027898" sldId="270"/>
            <ac:picMk id="14" creationId="{3E7D8AC0-D02A-4C51-BD68-6BEC6206EB49}"/>
          </ac:picMkLst>
        </pc:picChg>
        <pc:picChg chg="mod">
          <ac:chgData name="takao shun" userId="01825ee65df99981" providerId="LiveId" clId="{EF2C1E05-47FB-4407-B222-4C42F04069EE}" dt="2021-07-16T14:30:26.390" v="3"/>
          <ac:picMkLst>
            <pc:docMk/>
            <pc:sldMk cId="3480027898" sldId="270"/>
            <ac:picMk id="15" creationId="{ADE75FEB-6CBA-4CA0-91CE-0B1FC0CFF08A}"/>
          </ac:picMkLst>
        </pc:picChg>
        <pc:cxnChg chg="mod topLvl">
          <ac:chgData name="takao shun" userId="01825ee65df99981" providerId="LiveId" clId="{EF2C1E05-47FB-4407-B222-4C42F04069EE}" dt="2021-07-18T05:27:50.640" v="1782" actId="164"/>
          <ac:cxnSpMkLst>
            <pc:docMk/>
            <pc:sldMk cId="3480027898" sldId="270"/>
            <ac:cxnSpMk id="14" creationId="{BCF38430-A88F-48F7-85FE-90556D864187}"/>
          </ac:cxnSpMkLst>
        </pc:cxnChg>
        <pc:cxnChg chg="del mod topLvl">
          <ac:chgData name="takao shun" userId="01825ee65df99981" providerId="LiveId" clId="{EF2C1E05-47FB-4407-B222-4C42F04069EE}" dt="2021-07-18T05:27:23.567" v="1741" actId="478"/>
          <ac:cxnSpMkLst>
            <pc:docMk/>
            <pc:sldMk cId="3480027898" sldId="270"/>
            <ac:cxnSpMk id="15" creationId="{A49CED1C-7509-4EEA-A59F-B9CA5572F692}"/>
          </ac:cxnSpMkLst>
        </pc:cxnChg>
        <pc:cxnChg chg="mod topLvl">
          <ac:chgData name="takao shun" userId="01825ee65df99981" providerId="LiveId" clId="{EF2C1E05-47FB-4407-B222-4C42F04069EE}" dt="2021-07-18T05:27:50.640" v="1782" actId="164"/>
          <ac:cxnSpMkLst>
            <pc:docMk/>
            <pc:sldMk cId="3480027898" sldId="270"/>
            <ac:cxnSpMk id="16" creationId="{303838AD-27AF-4DF1-94E9-1D6CD631B596}"/>
          </ac:cxnSpMkLst>
        </pc:cxnChg>
        <pc:cxnChg chg="add mod">
          <ac:chgData name="takao shun" userId="01825ee65df99981" providerId="LiveId" clId="{EF2C1E05-47FB-4407-B222-4C42F04069EE}" dt="2021-07-18T05:27:50.640" v="1782" actId="164"/>
          <ac:cxnSpMkLst>
            <pc:docMk/>
            <pc:sldMk cId="3480027898" sldId="270"/>
            <ac:cxnSpMk id="18" creationId="{6CA723C6-493C-4E64-A202-1C614BCD1047}"/>
          </ac:cxnSpMkLst>
        </pc:cxnChg>
      </pc:sldChg>
      <pc:sldChg chg="addSp delSp modSp new mod">
        <pc:chgData name="takao shun" userId="01825ee65df99981" providerId="LiveId" clId="{EF2C1E05-47FB-4407-B222-4C42F04069EE}" dt="2021-07-20T23:51:48.916" v="2037" actId="207"/>
        <pc:sldMkLst>
          <pc:docMk/>
          <pc:sldMk cId="667907702" sldId="271"/>
        </pc:sldMkLst>
        <pc:spChg chg="del">
          <ac:chgData name="takao shun" userId="01825ee65df99981" providerId="LiveId" clId="{EF2C1E05-47FB-4407-B222-4C42F04069EE}" dt="2021-07-16T14:31:53.751" v="13" actId="478"/>
          <ac:spMkLst>
            <pc:docMk/>
            <pc:sldMk cId="667907702" sldId="271"/>
            <ac:spMk id="2" creationId="{41DCC8D7-63A5-40A7-BA10-89A2101CABDA}"/>
          </ac:spMkLst>
        </pc:spChg>
        <pc:spChg chg="del">
          <ac:chgData name="takao shun" userId="01825ee65df99981" providerId="LiveId" clId="{EF2C1E05-47FB-4407-B222-4C42F04069EE}" dt="2021-07-16T14:31:53.009" v="12" actId="478"/>
          <ac:spMkLst>
            <pc:docMk/>
            <pc:sldMk cId="667907702" sldId="271"/>
            <ac:spMk id="3" creationId="{6147164A-12CF-4ABF-BF02-09E1FB72E95E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7" creationId="{3EC696D0-59AD-40BC-AE8B-526CA0C0435F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8" creationId="{7563E300-56CF-4BD4-9EA1-609DDE001ED9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9" creationId="{F831C3C3-5151-4BBA-97AC-CD435ACC2E76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10" creationId="{5024CDCC-656E-4AAE-A29F-5B2CFD21EF42}"/>
          </ac:spMkLst>
        </pc:spChg>
        <pc:spChg chg="del mod topLvl">
          <ac:chgData name="takao shun" userId="01825ee65df99981" providerId="LiveId" clId="{EF2C1E05-47FB-4407-B222-4C42F04069EE}" dt="2021-07-18T07:48:07.169" v="1893" actId="478"/>
          <ac:spMkLst>
            <pc:docMk/>
            <pc:sldMk cId="667907702" sldId="271"/>
            <ac:spMk id="11" creationId="{56371E8C-BD48-49ED-A2EE-87B51776EA34}"/>
          </ac:spMkLst>
        </pc:spChg>
        <pc:spChg chg="del mod topLvl">
          <ac:chgData name="takao shun" userId="01825ee65df99981" providerId="LiveId" clId="{EF2C1E05-47FB-4407-B222-4C42F04069EE}" dt="2021-07-18T07:48:10.385" v="1894" actId="478"/>
          <ac:spMkLst>
            <pc:docMk/>
            <pc:sldMk cId="667907702" sldId="271"/>
            <ac:spMk id="12" creationId="{6B3121F9-D1C7-441C-AC06-0AEADBE8C722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13" creationId="{1BFFA014-952F-48C3-B3AD-8102A155EBBF}"/>
          </ac:spMkLst>
        </pc:spChg>
        <pc:spChg chg="mod topLvl">
          <ac:chgData name="takao shun" userId="01825ee65df99981" providerId="LiveId" clId="{EF2C1E05-47FB-4407-B222-4C42F04069EE}" dt="2021-07-18T07:15:16.197" v="1850" actId="338"/>
          <ac:spMkLst>
            <pc:docMk/>
            <pc:sldMk cId="667907702" sldId="271"/>
            <ac:spMk id="14" creationId="{97F7B6AC-3ECA-41B0-8A90-987714754E7C}"/>
          </ac:spMkLst>
        </pc:spChg>
        <pc:spChg chg="add mod">
          <ac:chgData name="takao shun" userId="01825ee65df99981" providerId="LiveId" clId="{EF2C1E05-47FB-4407-B222-4C42F04069EE}" dt="2021-07-18T07:47:59.297" v="1892" actId="20577"/>
          <ac:spMkLst>
            <pc:docMk/>
            <pc:sldMk cId="667907702" sldId="271"/>
            <ac:spMk id="18" creationId="{9F814522-4B31-4B9A-9F30-9ECB6560DD78}"/>
          </ac:spMkLst>
        </pc:spChg>
        <pc:spChg chg="add mod">
          <ac:chgData name="takao shun" userId="01825ee65df99981" providerId="LiveId" clId="{EF2C1E05-47FB-4407-B222-4C42F04069EE}" dt="2021-07-20T23:51:48.916" v="2037" actId="207"/>
          <ac:spMkLst>
            <pc:docMk/>
            <pc:sldMk cId="667907702" sldId="271"/>
            <ac:spMk id="19" creationId="{74021781-98FC-46BB-9D58-F40BBF088BEC}"/>
          </ac:spMkLst>
        </pc:spChg>
        <pc:spChg chg="mod">
          <ac:chgData name="takao shun" userId="01825ee65df99981" providerId="LiveId" clId="{EF2C1E05-47FB-4407-B222-4C42F04069EE}" dt="2021-07-19T23:02:10.794" v="2034" actId="403"/>
          <ac:spMkLst>
            <pc:docMk/>
            <pc:sldMk cId="667907702" sldId="271"/>
            <ac:spMk id="24" creationId="{2C024665-803B-4ABA-9B5F-11C967C24660}"/>
          </ac:spMkLst>
        </pc:spChg>
        <pc:spChg chg="mod">
          <ac:chgData name="takao shun" userId="01825ee65df99981" providerId="LiveId" clId="{EF2C1E05-47FB-4407-B222-4C42F04069EE}" dt="2021-07-19T23:02:05.297" v="2030" actId="403"/>
          <ac:spMkLst>
            <pc:docMk/>
            <pc:sldMk cId="667907702" sldId="271"/>
            <ac:spMk id="29" creationId="{A7ED2B4A-B6C0-48E0-900E-724D3F9845B3}"/>
          </ac:spMkLst>
        </pc:spChg>
        <pc:grpChg chg="add mod">
          <ac:chgData name="takao shun" userId="01825ee65df99981" providerId="LiveId" clId="{EF2C1E05-47FB-4407-B222-4C42F04069EE}" dt="2021-07-18T07:15:16.197" v="1850" actId="338"/>
          <ac:grpSpMkLst>
            <pc:docMk/>
            <pc:sldMk cId="667907702" sldId="271"/>
            <ac:grpSpMk id="2" creationId="{7D3820ED-9C28-44B7-9E16-C1E8EB7E0B11}"/>
          </ac:grpSpMkLst>
        </pc:grpChg>
        <pc:grpChg chg="add mod">
          <ac:chgData name="takao shun" userId="01825ee65df99981" providerId="LiveId" clId="{EF2C1E05-47FB-4407-B222-4C42F04069EE}" dt="2021-07-18T07:15:16.197" v="1850" actId="338"/>
          <ac:grpSpMkLst>
            <pc:docMk/>
            <pc:sldMk cId="667907702" sldId="271"/>
            <ac:grpSpMk id="3" creationId="{A80C673B-35D6-41D8-9D10-A690318E597E}"/>
          </ac:grpSpMkLst>
        </pc:grpChg>
        <pc:grpChg chg="add del mod">
          <ac:chgData name="takao shun" userId="01825ee65df99981" providerId="LiveId" clId="{EF2C1E05-47FB-4407-B222-4C42F04069EE}" dt="2021-07-16T14:32:24.435" v="26" actId="165"/>
          <ac:grpSpMkLst>
            <pc:docMk/>
            <pc:sldMk cId="667907702" sldId="271"/>
            <ac:grpSpMk id="4" creationId="{7FF6A056-0CBC-4A01-9094-CD3C7C8476E4}"/>
          </ac:grpSpMkLst>
        </pc:grpChg>
        <pc:grpChg chg="add del mod">
          <ac:chgData name="takao shun" userId="01825ee65df99981" providerId="LiveId" clId="{EF2C1E05-47FB-4407-B222-4C42F04069EE}" dt="2021-07-16T14:32:33.641" v="28" actId="165"/>
          <ac:grpSpMkLst>
            <pc:docMk/>
            <pc:sldMk cId="667907702" sldId="271"/>
            <ac:grpSpMk id="15" creationId="{640FDDF3-782F-4940-9446-21FEE14BCC35}"/>
          </ac:grpSpMkLst>
        </pc:grpChg>
        <pc:grpChg chg="add del mod">
          <ac:chgData name="takao shun" userId="01825ee65df99981" providerId="LiveId" clId="{EF2C1E05-47FB-4407-B222-4C42F04069EE}" dt="2021-07-18T07:11:50.870" v="1798" actId="165"/>
          <ac:grpSpMkLst>
            <pc:docMk/>
            <pc:sldMk cId="667907702" sldId="271"/>
            <ac:grpSpMk id="16" creationId="{F24E7CB1-AE5D-4DBE-8CF0-81F5D72808C3}"/>
          </ac:grpSpMkLst>
        </pc:grpChg>
        <pc:grpChg chg="add del mod">
          <ac:chgData name="takao shun" userId="01825ee65df99981" providerId="LiveId" clId="{EF2C1E05-47FB-4407-B222-4C42F04069EE}" dt="2021-07-18T07:11:50.870" v="1798" actId="165"/>
          <ac:grpSpMkLst>
            <pc:docMk/>
            <pc:sldMk cId="667907702" sldId="271"/>
            <ac:grpSpMk id="17" creationId="{6413650A-A48B-4940-9348-4BA8602BFD1A}"/>
          </ac:grpSpMkLst>
        </pc:grpChg>
        <pc:grpChg chg="add mod">
          <ac:chgData name="takao shun" userId="01825ee65df99981" providerId="LiveId" clId="{EF2C1E05-47FB-4407-B222-4C42F04069EE}" dt="2021-07-18T08:03:09.655" v="1907" actId="1076"/>
          <ac:grpSpMkLst>
            <pc:docMk/>
            <pc:sldMk cId="667907702" sldId="271"/>
            <ac:grpSpMk id="20" creationId="{ECF6E342-6F0E-44B6-922A-41F4C621A339}"/>
          </ac:grpSpMkLst>
        </pc:grpChg>
        <pc:grpChg chg="add mod">
          <ac:chgData name="takao shun" userId="01825ee65df99981" providerId="LiveId" clId="{EF2C1E05-47FB-4407-B222-4C42F04069EE}" dt="2021-07-19T23:01:34.129" v="2002" actId="1037"/>
          <ac:grpSpMkLst>
            <pc:docMk/>
            <pc:sldMk cId="667907702" sldId="271"/>
            <ac:grpSpMk id="25" creationId="{0E6FE906-259B-4D47-918D-113E43DAD5C3}"/>
          </ac:grpSpMkLst>
        </pc:grpChg>
        <pc:picChg chg="mod topLvl">
          <ac:chgData name="takao shun" userId="01825ee65df99981" providerId="LiveId" clId="{EF2C1E05-47FB-4407-B222-4C42F04069EE}" dt="2021-07-18T07:15:16.197" v="1850" actId="338"/>
          <ac:picMkLst>
            <pc:docMk/>
            <pc:sldMk cId="667907702" sldId="271"/>
            <ac:picMk id="5" creationId="{32639998-6A9A-4043-8BD7-8FB1DC397ADE}"/>
          </ac:picMkLst>
        </pc:picChg>
        <pc:picChg chg="mod topLvl">
          <ac:chgData name="takao shun" userId="01825ee65df99981" providerId="LiveId" clId="{EF2C1E05-47FB-4407-B222-4C42F04069EE}" dt="2021-07-18T07:15:16.197" v="1850" actId="338"/>
          <ac:picMkLst>
            <pc:docMk/>
            <pc:sldMk cId="667907702" sldId="271"/>
            <ac:picMk id="6" creationId="{9948912C-0264-4824-9F77-E2BE645B6957}"/>
          </ac:picMkLst>
        </pc:picChg>
        <pc:cxnChg chg="mod">
          <ac:chgData name="takao shun" userId="01825ee65df99981" providerId="LiveId" clId="{EF2C1E05-47FB-4407-B222-4C42F04069EE}" dt="2021-07-18T08:02:58.709" v="1905"/>
          <ac:cxnSpMkLst>
            <pc:docMk/>
            <pc:sldMk cId="667907702" sldId="271"/>
            <ac:cxnSpMk id="21" creationId="{86ADC23C-429B-456E-B2F2-68DC6AF15166}"/>
          </ac:cxnSpMkLst>
        </pc:cxnChg>
        <pc:cxnChg chg="mod">
          <ac:chgData name="takao shun" userId="01825ee65df99981" providerId="LiveId" clId="{EF2C1E05-47FB-4407-B222-4C42F04069EE}" dt="2021-07-18T08:02:58.709" v="1905"/>
          <ac:cxnSpMkLst>
            <pc:docMk/>
            <pc:sldMk cId="667907702" sldId="271"/>
            <ac:cxnSpMk id="22" creationId="{38B65D84-7FAD-4699-8DC8-3BF5966D831C}"/>
          </ac:cxnSpMkLst>
        </pc:cxnChg>
        <pc:cxnChg chg="mod">
          <ac:chgData name="takao shun" userId="01825ee65df99981" providerId="LiveId" clId="{EF2C1E05-47FB-4407-B222-4C42F04069EE}" dt="2021-07-18T08:02:58.709" v="1905"/>
          <ac:cxnSpMkLst>
            <pc:docMk/>
            <pc:sldMk cId="667907702" sldId="271"/>
            <ac:cxnSpMk id="23" creationId="{BF7231B0-9304-4932-98EC-5ADA69E0C05C}"/>
          </ac:cxnSpMkLst>
        </pc:cxnChg>
        <pc:cxnChg chg="mod">
          <ac:chgData name="takao shun" userId="01825ee65df99981" providerId="LiveId" clId="{EF2C1E05-47FB-4407-B222-4C42F04069EE}" dt="2021-07-19T23:01:28.688" v="1929"/>
          <ac:cxnSpMkLst>
            <pc:docMk/>
            <pc:sldMk cId="667907702" sldId="271"/>
            <ac:cxnSpMk id="26" creationId="{E3A89B81-2CA4-4635-9E7A-78B07B458020}"/>
          </ac:cxnSpMkLst>
        </pc:cxnChg>
        <pc:cxnChg chg="mod">
          <ac:chgData name="takao shun" userId="01825ee65df99981" providerId="LiveId" clId="{EF2C1E05-47FB-4407-B222-4C42F04069EE}" dt="2021-07-19T23:01:28.688" v="1929"/>
          <ac:cxnSpMkLst>
            <pc:docMk/>
            <pc:sldMk cId="667907702" sldId="271"/>
            <ac:cxnSpMk id="27" creationId="{F0C6B85F-8CE7-45D7-9DC7-BDB77D62A2FF}"/>
          </ac:cxnSpMkLst>
        </pc:cxnChg>
        <pc:cxnChg chg="mod">
          <ac:chgData name="takao shun" userId="01825ee65df99981" providerId="LiveId" clId="{EF2C1E05-47FB-4407-B222-4C42F04069EE}" dt="2021-07-19T23:01:28.688" v="1929"/>
          <ac:cxnSpMkLst>
            <pc:docMk/>
            <pc:sldMk cId="667907702" sldId="271"/>
            <ac:cxnSpMk id="28" creationId="{D7361255-5E34-4B2A-84E4-816F1A5FB48C}"/>
          </ac:cxnSpMkLst>
        </pc:cxnChg>
      </pc:sldChg>
      <pc:sldChg chg="addSp delSp modSp new mod ord">
        <pc:chgData name="takao shun" userId="01825ee65df99981" providerId="LiveId" clId="{EF2C1E05-47FB-4407-B222-4C42F04069EE}" dt="2021-07-20T23:51:36.417" v="2035" actId="207"/>
        <pc:sldMkLst>
          <pc:docMk/>
          <pc:sldMk cId="971617" sldId="272"/>
        </pc:sldMkLst>
        <pc:spChg chg="del">
          <ac:chgData name="takao shun" userId="01825ee65df99981" providerId="LiveId" clId="{EF2C1E05-47FB-4407-B222-4C42F04069EE}" dt="2021-07-17T08:20:24.048" v="73" actId="478"/>
          <ac:spMkLst>
            <pc:docMk/>
            <pc:sldMk cId="971617" sldId="272"/>
            <ac:spMk id="2" creationId="{E36E7396-674E-4C3B-BC27-CDD965DD0530}"/>
          </ac:spMkLst>
        </pc:spChg>
        <pc:spChg chg="del">
          <ac:chgData name="takao shun" userId="01825ee65df99981" providerId="LiveId" clId="{EF2C1E05-47FB-4407-B222-4C42F04069EE}" dt="2021-07-17T08:20:21.346" v="72" actId="478"/>
          <ac:spMkLst>
            <pc:docMk/>
            <pc:sldMk cId="971617" sldId="272"/>
            <ac:spMk id="3" creationId="{41800882-B848-48A5-B2AF-694F59B59648}"/>
          </ac:spMkLst>
        </pc:spChg>
        <pc:spChg chg="add mod">
          <ac:chgData name="takao shun" userId="01825ee65df99981" providerId="LiveId" clId="{EF2C1E05-47FB-4407-B222-4C42F04069EE}" dt="2021-07-17T08:55:54.308" v="1262" actId="465"/>
          <ac:spMkLst>
            <pc:docMk/>
            <pc:sldMk cId="971617" sldId="272"/>
            <ac:spMk id="10" creationId="{4EECD609-3A70-4558-B26D-5686E71E2CD4}"/>
          </ac:spMkLst>
        </pc:spChg>
        <pc:spChg chg="add del mod">
          <ac:chgData name="takao shun" userId="01825ee65df99981" providerId="LiveId" clId="{EF2C1E05-47FB-4407-B222-4C42F04069EE}" dt="2021-07-17T08:25:28.237" v="340" actId="478"/>
          <ac:spMkLst>
            <pc:docMk/>
            <pc:sldMk cId="971617" sldId="272"/>
            <ac:spMk id="11" creationId="{CC768FED-CE7A-4A42-8588-BD5166C68EBE}"/>
          </ac:spMkLst>
        </pc:spChg>
        <pc:spChg chg="add mod">
          <ac:chgData name="takao shun" userId="01825ee65df99981" providerId="LiveId" clId="{EF2C1E05-47FB-4407-B222-4C42F04069EE}" dt="2021-07-20T23:51:36.417" v="2035" actId="207"/>
          <ac:spMkLst>
            <pc:docMk/>
            <pc:sldMk cId="971617" sldId="272"/>
            <ac:spMk id="12" creationId="{921BD3C8-BFF3-48AF-99A1-250727F7FE58}"/>
          </ac:spMkLst>
        </pc:spChg>
        <pc:spChg chg="add mod">
          <ac:chgData name="takao shun" userId="01825ee65df99981" providerId="LiveId" clId="{EF2C1E05-47FB-4407-B222-4C42F04069EE}" dt="2021-07-20T23:51:36.417" v="2035" actId="207"/>
          <ac:spMkLst>
            <pc:docMk/>
            <pc:sldMk cId="971617" sldId="272"/>
            <ac:spMk id="13" creationId="{15D3BD0A-1C48-41EF-A237-BAADE19F9396}"/>
          </ac:spMkLst>
        </pc:spChg>
        <pc:spChg chg="add mod">
          <ac:chgData name="takao shun" userId="01825ee65df99981" providerId="LiveId" clId="{EF2C1E05-47FB-4407-B222-4C42F04069EE}" dt="2021-07-17T08:55:54.308" v="1262" actId="465"/>
          <ac:spMkLst>
            <pc:docMk/>
            <pc:sldMk cId="971617" sldId="272"/>
            <ac:spMk id="14" creationId="{771D6736-F952-4248-BB63-3BED446C12FA}"/>
          </ac:spMkLst>
        </pc:spChg>
        <pc:spChg chg="add mod">
          <ac:chgData name="takao shun" userId="01825ee65df99981" providerId="LiveId" clId="{EF2C1E05-47FB-4407-B222-4C42F04069EE}" dt="2021-07-17T08:55:54.308" v="1262" actId="465"/>
          <ac:spMkLst>
            <pc:docMk/>
            <pc:sldMk cId="971617" sldId="272"/>
            <ac:spMk id="15" creationId="{A77AE4EF-E98D-48CF-9952-9D867866D04F}"/>
          </ac:spMkLst>
        </pc:spChg>
        <pc:spChg chg="add del mod">
          <ac:chgData name="takao shun" userId="01825ee65df99981" providerId="LiveId" clId="{EF2C1E05-47FB-4407-B222-4C42F04069EE}" dt="2021-07-17T15:06:56.156" v="1549" actId="478"/>
          <ac:spMkLst>
            <pc:docMk/>
            <pc:sldMk cId="971617" sldId="272"/>
            <ac:spMk id="16" creationId="{21084F05-DE72-4467-A503-F2278173733C}"/>
          </ac:spMkLst>
        </pc:spChg>
        <pc:spChg chg="add mod">
          <ac:chgData name="takao shun" userId="01825ee65df99981" providerId="LiveId" clId="{EF2C1E05-47FB-4407-B222-4C42F04069EE}" dt="2021-07-17T08:56:43.242" v="1268" actId="1036"/>
          <ac:spMkLst>
            <pc:docMk/>
            <pc:sldMk cId="971617" sldId="272"/>
            <ac:spMk id="17" creationId="{6DB25DC6-735D-4D09-A08E-7BBF3E7DCEEF}"/>
          </ac:spMkLst>
        </pc:spChg>
        <pc:spChg chg="add mod">
          <ac:chgData name="takao shun" userId="01825ee65df99981" providerId="LiveId" clId="{EF2C1E05-47FB-4407-B222-4C42F04069EE}" dt="2021-07-17T15:08:01.341" v="1572" actId="20577"/>
          <ac:spMkLst>
            <pc:docMk/>
            <pc:sldMk cId="971617" sldId="272"/>
            <ac:spMk id="18" creationId="{E0BCC580-F8A3-4F66-B9AE-0F0D168C5F74}"/>
          </ac:spMkLst>
        </pc:spChg>
        <pc:spChg chg="add mod">
          <ac:chgData name="takao shun" userId="01825ee65df99981" providerId="LiveId" clId="{EF2C1E05-47FB-4407-B222-4C42F04069EE}" dt="2021-07-17T08:40:55.523" v="981" actId="1038"/>
          <ac:spMkLst>
            <pc:docMk/>
            <pc:sldMk cId="971617" sldId="272"/>
            <ac:spMk id="19" creationId="{249774FA-D145-41C6-B457-2CE2868B45C0}"/>
          </ac:spMkLst>
        </pc:spChg>
        <pc:spChg chg="add mod">
          <ac:chgData name="takao shun" userId="01825ee65df99981" providerId="LiveId" clId="{EF2C1E05-47FB-4407-B222-4C42F04069EE}" dt="2021-07-17T15:07:51.160" v="1558" actId="20577"/>
          <ac:spMkLst>
            <pc:docMk/>
            <pc:sldMk cId="971617" sldId="272"/>
            <ac:spMk id="20" creationId="{44506117-DEDB-4700-9186-50AB304D666C}"/>
          </ac:spMkLst>
        </pc:spChg>
        <pc:spChg chg="add mod">
          <ac:chgData name="takao shun" userId="01825ee65df99981" providerId="LiveId" clId="{EF2C1E05-47FB-4407-B222-4C42F04069EE}" dt="2021-07-17T08:40:55.523" v="981" actId="1038"/>
          <ac:spMkLst>
            <pc:docMk/>
            <pc:sldMk cId="971617" sldId="272"/>
            <ac:spMk id="21" creationId="{B631F5CB-439D-46A2-81A6-6F1A1F7C7DD7}"/>
          </ac:spMkLst>
        </pc:spChg>
        <pc:spChg chg="add mod">
          <ac:chgData name="takao shun" userId="01825ee65df99981" providerId="LiveId" clId="{EF2C1E05-47FB-4407-B222-4C42F04069EE}" dt="2021-07-20T23:51:36.417" v="2035" actId="207"/>
          <ac:spMkLst>
            <pc:docMk/>
            <pc:sldMk cId="971617" sldId="272"/>
            <ac:spMk id="22" creationId="{20C26DF0-67F7-4603-8B06-73B10410FDD4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6" creationId="{FC31E43B-C427-474F-885F-F3E78A8DF5E7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7" creationId="{5566C40E-02D6-453D-B18C-F16CFAF441EB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8" creationId="{94E5142B-32E4-4810-B4AD-A6F3633D6CB5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29" creationId="{43D7ABA6-6F6A-43D7-9BB2-01B6C7F8AED9}"/>
          </ac:spMkLst>
        </pc:spChg>
        <pc:spChg chg="add mod">
          <ac:chgData name="takao shun" userId="01825ee65df99981" providerId="LiveId" clId="{EF2C1E05-47FB-4407-B222-4C42F04069EE}" dt="2021-07-17T15:06:39.842" v="1548" actId="255"/>
          <ac:spMkLst>
            <pc:docMk/>
            <pc:sldMk cId="971617" sldId="272"/>
            <ac:spMk id="30" creationId="{40D86C03-277E-41DB-81E3-6494641AF2F6}"/>
          </ac:spMkLst>
        </pc:spChg>
        <pc:graphicFrameChg chg="add del mod">
          <ac:chgData name="takao shun" userId="01825ee65df99981" providerId="LiveId" clId="{EF2C1E05-47FB-4407-B222-4C42F04069EE}" dt="2021-07-17T08:21:10.486" v="82" actId="478"/>
          <ac:graphicFrameMkLst>
            <pc:docMk/>
            <pc:sldMk cId="971617" sldId="272"/>
            <ac:graphicFrameMk id="4" creationId="{3268CBA1-6E04-4EE6-B9A7-271AE5094A12}"/>
          </ac:graphicFrameMkLst>
        </pc:graphicFrameChg>
        <pc:graphicFrameChg chg="add del mod">
          <ac:chgData name="takao shun" userId="01825ee65df99981" providerId="LiveId" clId="{EF2C1E05-47FB-4407-B222-4C42F04069EE}" dt="2021-07-17T08:21:22.771" v="86" actId="478"/>
          <ac:graphicFrameMkLst>
            <pc:docMk/>
            <pc:sldMk cId="971617" sldId="272"/>
            <ac:graphicFrameMk id="5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21:31.640" v="91"/>
          <ac:graphicFrameMkLst>
            <pc:docMk/>
            <pc:sldMk cId="971617" sldId="272"/>
            <ac:graphicFrameMk id="6" creationId="{3268CBA1-6E04-4EE6-B9A7-271AE5094A12}"/>
          </ac:graphicFrameMkLst>
        </pc:graphicFrameChg>
        <pc:graphicFrameChg chg="add del mod">
          <ac:chgData name="takao shun" userId="01825ee65df99981" providerId="LiveId" clId="{EF2C1E05-47FB-4407-B222-4C42F04069EE}" dt="2021-07-17T08:21:36.340" v="95" actId="478"/>
          <ac:graphicFrameMkLst>
            <pc:docMk/>
            <pc:sldMk cId="971617" sldId="272"/>
            <ac:graphicFrameMk id="7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21:41.201" v="100"/>
          <ac:graphicFrameMkLst>
            <pc:docMk/>
            <pc:sldMk cId="971617" sldId="272"/>
            <ac:graphicFrameMk id="8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39:09.906" v="842"/>
          <ac:graphicFrameMkLst>
            <pc:docMk/>
            <pc:sldMk cId="971617" sldId="272"/>
            <ac:graphicFrameMk id="22" creationId="{3268CBA1-6E04-4EE6-B9A7-271AE5094A12}"/>
          </ac:graphicFrameMkLst>
        </pc:graphicFrameChg>
        <pc:graphicFrameChg chg="add mod">
          <ac:chgData name="takao shun" userId="01825ee65df99981" providerId="LiveId" clId="{EF2C1E05-47FB-4407-B222-4C42F04069EE}" dt="2021-07-17T08:54:06.233" v="987"/>
          <ac:graphicFrameMkLst>
            <pc:docMk/>
            <pc:sldMk cId="971617" sldId="272"/>
            <ac:graphicFrameMk id="24" creationId="{3268CBA1-6E04-4EE6-B9A7-271AE5094A12}"/>
          </ac:graphicFrameMkLst>
        </pc:graphicFrameChg>
        <pc:picChg chg="add del mod modCrop">
          <ac:chgData name="takao shun" userId="01825ee65df99981" providerId="LiveId" clId="{EF2C1E05-47FB-4407-B222-4C42F04069EE}" dt="2021-07-17T08:39:44.388" v="910" actId="478"/>
          <ac:picMkLst>
            <pc:docMk/>
            <pc:sldMk cId="971617" sldId="272"/>
            <ac:picMk id="9" creationId="{0A4C0BA1-1B2E-4B43-80B1-74169104CB6B}"/>
          </ac:picMkLst>
        </pc:picChg>
        <pc:picChg chg="add del mod ord modCrop">
          <ac:chgData name="takao shun" userId="01825ee65df99981" providerId="LiveId" clId="{EF2C1E05-47FB-4407-B222-4C42F04069EE}" dt="2021-07-17T08:55:12.877" v="1190" actId="478"/>
          <ac:picMkLst>
            <pc:docMk/>
            <pc:sldMk cId="971617" sldId="272"/>
            <ac:picMk id="23" creationId="{10FE8E78-4DD8-4024-98FF-EEFBAF4CB62F}"/>
          </ac:picMkLst>
        </pc:picChg>
        <pc:picChg chg="add mod ord modCrop">
          <ac:chgData name="takao shun" userId="01825ee65df99981" providerId="LiveId" clId="{EF2C1E05-47FB-4407-B222-4C42F04069EE}" dt="2021-07-17T08:56:32.364" v="1266" actId="732"/>
          <ac:picMkLst>
            <pc:docMk/>
            <pc:sldMk cId="971617" sldId="272"/>
            <ac:picMk id="25" creationId="{F9439441-D7C7-4B3A-AA97-BE93C58BC6F2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057400" y="3367089"/>
            <a:ext cx="23317200" cy="7162800"/>
          </a:xfrm>
        </p:spPr>
        <p:txBody>
          <a:bodyPr anchor="b"/>
          <a:lstStyle>
            <a:lvl1pPr algn="ctr"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429000" y="10806114"/>
            <a:ext cx="20574000" cy="4967286"/>
          </a:xfrm>
        </p:spPr>
        <p:txBody>
          <a:bodyPr/>
          <a:lstStyle>
            <a:lvl1pPr marL="0" indent="0" algn="ctr">
              <a:buNone/>
              <a:defRPr sz="7200"/>
            </a:lvl1pPr>
            <a:lvl2pPr marL="1371600" indent="0" algn="ctr">
              <a:buNone/>
              <a:defRPr sz="6000"/>
            </a:lvl2pPr>
            <a:lvl3pPr marL="2743200" indent="0" algn="ctr">
              <a:buNone/>
              <a:defRPr sz="5400"/>
            </a:lvl3pPr>
            <a:lvl4pPr marL="4114800" indent="0" algn="ctr">
              <a:buNone/>
              <a:defRPr sz="4800"/>
            </a:lvl4pPr>
            <a:lvl5pPr marL="5486400" indent="0" algn="ctr">
              <a:buNone/>
              <a:defRPr sz="4800"/>
            </a:lvl5pPr>
            <a:lvl6pPr marL="6858000" indent="0" algn="ctr">
              <a:buNone/>
              <a:defRPr sz="4800"/>
            </a:lvl6pPr>
            <a:lvl7pPr marL="8229600" indent="0" algn="ctr">
              <a:buNone/>
              <a:defRPr sz="4800"/>
            </a:lvl7pPr>
            <a:lvl8pPr marL="9601200" indent="0" algn="ctr">
              <a:buNone/>
              <a:defRPr sz="4800"/>
            </a:lvl8pPr>
            <a:lvl9pPr marL="10972800" indent="0" algn="ctr">
              <a:buNone/>
              <a:defRPr sz="48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01745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9925948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9631027" y="1095375"/>
            <a:ext cx="5915025" cy="1743551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885952" y="1095375"/>
            <a:ext cx="17402175" cy="1743551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813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460141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71664" y="5129219"/>
            <a:ext cx="23660100" cy="8558211"/>
          </a:xfrm>
        </p:spPr>
        <p:txBody>
          <a:bodyPr anchor="b"/>
          <a:lstStyle>
            <a:lvl1pPr>
              <a:defRPr sz="18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71664" y="13768394"/>
            <a:ext cx="23660100" cy="4500561"/>
          </a:xfrm>
        </p:spPr>
        <p:txBody>
          <a:bodyPr/>
          <a:lstStyle>
            <a:lvl1pPr marL="0" indent="0">
              <a:buNone/>
              <a:defRPr sz="7200">
                <a:solidFill>
                  <a:schemeClr val="tx1"/>
                </a:solidFill>
              </a:defRPr>
            </a:lvl1pPr>
            <a:lvl2pPr marL="1371600" indent="0">
              <a:buNone/>
              <a:defRPr sz="6000">
                <a:solidFill>
                  <a:schemeClr val="tx1">
                    <a:tint val="75000"/>
                  </a:schemeClr>
                </a:solidFill>
              </a:defRPr>
            </a:lvl2pPr>
            <a:lvl3pPr marL="2743200" indent="0">
              <a:buNone/>
              <a:defRPr sz="5400">
                <a:solidFill>
                  <a:schemeClr val="tx1">
                    <a:tint val="75000"/>
                  </a:schemeClr>
                </a:solidFill>
              </a:defRPr>
            </a:lvl3pPr>
            <a:lvl4pPr marL="4114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4pPr>
            <a:lvl5pPr marL="54864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5pPr>
            <a:lvl6pPr marL="68580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6pPr>
            <a:lvl7pPr marL="82296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7pPr>
            <a:lvl8pPr marL="96012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8pPr>
            <a:lvl9pPr marL="10972800" indent="0">
              <a:buNone/>
              <a:defRPr sz="48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888319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8859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3887450" y="5476875"/>
            <a:ext cx="11658600" cy="1305401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653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095380"/>
            <a:ext cx="23660100" cy="3976689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9526" y="5043489"/>
            <a:ext cx="11605020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889526" y="7515225"/>
            <a:ext cx="11605020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3887452" y="5043489"/>
            <a:ext cx="11662173" cy="2471736"/>
          </a:xfrm>
        </p:spPr>
        <p:txBody>
          <a:bodyPr anchor="b"/>
          <a:lstStyle>
            <a:lvl1pPr marL="0" indent="0">
              <a:buNone/>
              <a:defRPr sz="7200" b="1"/>
            </a:lvl1pPr>
            <a:lvl2pPr marL="1371600" indent="0">
              <a:buNone/>
              <a:defRPr sz="6000" b="1"/>
            </a:lvl2pPr>
            <a:lvl3pPr marL="2743200" indent="0">
              <a:buNone/>
              <a:defRPr sz="5400" b="1"/>
            </a:lvl3pPr>
            <a:lvl4pPr marL="4114800" indent="0">
              <a:buNone/>
              <a:defRPr sz="4800" b="1"/>
            </a:lvl4pPr>
            <a:lvl5pPr marL="5486400" indent="0">
              <a:buNone/>
              <a:defRPr sz="4800" b="1"/>
            </a:lvl5pPr>
            <a:lvl6pPr marL="6858000" indent="0">
              <a:buNone/>
              <a:defRPr sz="4800" b="1"/>
            </a:lvl6pPr>
            <a:lvl7pPr marL="8229600" indent="0">
              <a:buNone/>
              <a:defRPr sz="4800" b="1"/>
            </a:lvl7pPr>
            <a:lvl8pPr marL="9601200" indent="0">
              <a:buNone/>
              <a:defRPr sz="4800" b="1"/>
            </a:lvl8pPr>
            <a:lvl9pPr marL="10972800" indent="0">
              <a:buNone/>
              <a:defRPr sz="48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3887452" y="7515225"/>
            <a:ext cx="11662173" cy="1105376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737853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724264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871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1662173" y="2962280"/>
            <a:ext cx="13887450" cy="14620875"/>
          </a:xfrm>
        </p:spPr>
        <p:txBody>
          <a:bodyPr/>
          <a:lstStyle>
            <a:lvl1pPr>
              <a:defRPr sz="9600"/>
            </a:lvl1pPr>
            <a:lvl2pPr>
              <a:defRPr sz="8400"/>
            </a:lvl2pPr>
            <a:lvl3pPr>
              <a:defRPr sz="7200"/>
            </a:lvl3pPr>
            <a:lvl4pPr>
              <a:defRPr sz="6000"/>
            </a:lvl4pPr>
            <a:lvl5pPr>
              <a:defRPr sz="6000"/>
            </a:lvl5pPr>
            <a:lvl6pPr>
              <a:defRPr sz="6000"/>
            </a:lvl6pPr>
            <a:lvl7pPr>
              <a:defRPr sz="6000"/>
            </a:lvl7pPr>
            <a:lvl8pPr>
              <a:defRPr sz="6000"/>
            </a:lvl8pPr>
            <a:lvl9pPr>
              <a:defRPr sz="6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18712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889523" y="1371600"/>
            <a:ext cx="8847534" cy="4800600"/>
          </a:xfrm>
        </p:spPr>
        <p:txBody>
          <a:bodyPr anchor="b"/>
          <a:lstStyle>
            <a:lvl1pPr>
              <a:defRPr sz="96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1662173" y="2962280"/>
            <a:ext cx="13887450" cy="14620875"/>
          </a:xfrm>
        </p:spPr>
        <p:txBody>
          <a:bodyPr anchor="t"/>
          <a:lstStyle>
            <a:lvl1pPr marL="0" indent="0">
              <a:buNone/>
              <a:defRPr sz="9600"/>
            </a:lvl1pPr>
            <a:lvl2pPr marL="1371600" indent="0">
              <a:buNone/>
              <a:defRPr sz="8400"/>
            </a:lvl2pPr>
            <a:lvl3pPr marL="2743200" indent="0">
              <a:buNone/>
              <a:defRPr sz="7200"/>
            </a:lvl3pPr>
            <a:lvl4pPr marL="4114800" indent="0">
              <a:buNone/>
              <a:defRPr sz="6000"/>
            </a:lvl4pPr>
            <a:lvl5pPr marL="5486400" indent="0">
              <a:buNone/>
              <a:defRPr sz="6000"/>
            </a:lvl5pPr>
            <a:lvl6pPr marL="6858000" indent="0">
              <a:buNone/>
              <a:defRPr sz="6000"/>
            </a:lvl6pPr>
            <a:lvl7pPr marL="8229600" indent="0">
              <a:buNone/>
              <a:defRPr sz="6000"/>
            </a:lvl7pPr>
            <a:lvl8pPr marL="9601200" indent="0">
              <a:buNone/>
              <a:defRPr sz="6000"/>
            </a:lvl8pPr>
            <a:lvl9pPr marL="10972800" indent="0">
              <a:buNone/>
              <a:defRPr sz="6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889523" y="6172200"/>
            <a:ext cx="8847534" cy="11434764"/>
          </a:xfrm>
        </p:spPr>
        <p:txBody>
          <a:bodyPr/>
          <a:lstStyle>
            <a:lvl1pPr marL="0" indent="0">
              <a:buNone/>
              <a:defRPr sz="4800"/>
            </a:lvl1pPr>
            <a:lvl2pPr marL="1371600" indent="0">
              <a:buNone/>
              <a:defRPr sz="4200"/>
            </a:lvl2pPr>
            <a:lvl3pPr marL="2743200" indent="0">
              <a:buNone/>
              <a:defRPr sz="3600"/>
            </a:lvl3pPr>
            <a:lvl4pPr marL="4114800" indent="0">
              <a:buNone/>
              <a:defRPr sz="3000"/>
            </a:lvl4pPr>
            <a:lvl5pPr marL="5486400" indent="0">
              <a:buNone/>
              <a:defRPr sz="3000"/>
            </a:lvl5pPr>
            <a:lvl6pPr marL="6858000" indent="0">
              <a:buNone/>
              <a:defRPr sz="3000"/>
            </a:lvl6pPr>
            <a:lvl7pPr marL="8229600" indent="0">
              <a:buNone/>
              <a:defRPr sz="3000"/>
            </a:lvl7pPr>
            <a:lvl8pPr marL="9601200" indent="0">
              <a:buNone/>
              <a:defRPr sz="3000"/>
            </a:lvl8pPr>
            <a:lvl9pPr marL="10972800" indent="0">
              <a:buNone/>
              <a:defRPr sz="3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102549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885950" y="1095380"/>
            <a:ext cx="23660100" cy="397668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885950" y="5476875"/>
            <a:ext cx="23660100" cy="130540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8859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47D383-9A29-4666-9673-CF1CE98873EA}" type="datetimeFigureOut">
              <a:rPr kumimoji="1" lang="ja-JP" altLang="en-US" smtClean="0"/>
              <a:t>2021/7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086850" y="19069055"/>
            <a:ext cx="92583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9373850" y="19069055"/>
            <a:ext cx="6172200" cy="10953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06B4F5-4703-4371-A244-3577FE07899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011121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2743200" rtl="0" eaLnBrk="1" latinLnBrk="0" hangingPunct="1">
        <a:lnSpc>
          <a:spcPct val="90000"/>
        </a:lnSpc>
        <a:spcBef>
          <a:spcPct val="0"/>
        </a:spcBef>
        <a:buNone/>
        <a:defRPr kumimoji="1" sz="132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685800" indent="-685800" algn="l" defTabSz="2743200" rtl="0" eaLnBrk="1" latinLnBrk="0" hangingPunct="1">
        <a:lnSpc>
          <a:spcPct val="90000"/>
        </a:lnSpc>
        <a:spcBef>
          <a:spcPts val="3000"/>
        </a:spcBef>
        <a:buFont typeface="Arial" panose="020B0604020202020204" pitchFamily="34" charset="0"/>
        <a:buChar char="•"/>
        <a:defRPr kumimoji="1" sz="8400" kern="1200">
          <a:solidFill>
            <a:schemeClr val="tx1"/>
          </a:solidFill>
          <a:latin typeface="+mn-lt"/>
          <a:ea typeface="+mn-ea"/>
          <a:cs typeface="+mn-cs"/>
        </a:defRPr>
      </a:lvl1pPr>
      <a:lvl2pPr marL="2057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7200" kern="1200">
          <a:solidFill>
            <a:schemeClr val="tx1"/>
          </a:solidFill>
          <a:latin typeface="+mn-lt"/>
          <a:ea typeface="+mn-ea"/>
          <a:cs typeface="+mn-cs"/>
        </a:defRPr>
      </a:lvl2pPr>
      <a:lvl3pPr marL="3429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6000" kern="1200">
          <a:solidFill>
            <a:schemeClr val="tx1"/>
          </a:solidFill>
          <a:latin typeface="+mn-lt"/>
          <a:ea typeface="+mn-ea"/>
          <a:cs typeface="+mn-cs"/>
        </a:defRPr>
      </a:lvl3pPr>
      <a:lvl4pPr marL="4800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61722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75438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9154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102870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1658600" indent="-685800" algn="l" defTabSz="2743200" rtl="0" eaLnBrk="1" latinLnBrk="0" hangingPunct="1">
        <a:lnSpc>
          <a:spcPct val="90000"/>
        </a:lnSpc>
        <a:spcBef>
          <a:spcPts val="1500"/>
        </a:spcBef>
        <a:buFont typeface="Arial" panose="020B0604020202020204" pitchFamily="34" charset="0"/>
        <a:buChar char="•"/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2pPr>
      <a:lvl3pPr marL="2743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3pPr>
      <a:lvl4pPr marL="4114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4pPr>
      <a:lvl5pPr marL="54864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5pPr>
      <a:lvl6pPr marL="68580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6pPr>
      <a:lvl7pPr marL="82296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7pPr>
      <a:lvl8pPr marL="96012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8pPr>
      <a:lvl9pPr marL="10972800" algn="l" defTabSz="2743200" rtl="0" eaLnBrk="1" latinLnBrk="0" hangingPunct="1">
        <a:defRPr kumimoji="1" sz="5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1D00C355-8D93-4D60-944D-2ECB908A96A2}"/>
              </a:ext>
            </a:extLst>
          </p:cNvPr>
          <p:cNvGrpSpPr/>
          <p:nvPr/>
        </p:nvGrpSpPr>
        <p:grpSpPr>
          <a:xfrm>
            <a:off x="2276927" y="2290972"/>
            <a:ext cx="9411006" cy="6237119"/>
            <a:chOff x="2276927" y="2290972"/>
            <a:chExt cx="9411006" cy="6237119"/>
          </a:xfrm>
        </p:grpSpPr>
        <p:pic>
          <p:nvPicPr>
            <p:cNvPr id="5" name="図 4">
              <a:extLst>
                <a:ext uri="{FF2B5EF4-FFF2-40B4-BE49-F238E27FC236}">
                  <a16:creationId xmlns:a16="http://schemas.microsoft.com/office/drawing/2014/main" id="{05A0B8BB-75F4-49E1-9EE8-B6180A3AF4E4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765426" y="2290972"/>
              <a:ext cx="7935534" cy="6193590"/>
            </a:xfrm>
            <a:prstGeom prst="rect">
              <a:avLst/>
            </a:prstGeom>
          </p:spPr>
        </p:pic>
        <p:sp>
          <p:nvSpPr>
            <p:cNvPr id="6" name="テキスト ボックス 5">
              <a:extLst>
                <a:ext uri="{FF2B5EF4-FFF2-40B4-BE49-F238E27FC236}">
                  <a16:creationId xmlns:a16="http://schemas.microsoft.com/office/drawing/2014/main" id="{531812AD-403E-4B88-A079-DAC5897A9C16}"/>
                </a:ext>
              </a:extLst>
            </p:cNvPr>
            <p:cNvSpPr txBox="1"/>
            <p:nvPr/>
          </p:nvSpPr>
          <p:spPr>
            <a:xfrm>
              <a:off x="3832168" y="8158759"/>
              <a:ext cx="738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6Hr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テキスト ボックス 6">
              <a:extLst>
                <a:ext uri="{FF2B5EF4-FFF2-40B4-BE49-F238E27FC236}">
                  <a16:creationId xmlns:a16="http://schemas.microsoft.com/office/drawing/2014/main" id="{55B08221-F6CA-4925-AC98-DD828770AD91}"/>
                </a:ext>
              </a:extLst>
            </p:cNvPr>
            <p:cNvSpPr txBox="1"/>
            <p:nvPr/>
          </p:nvSpPr>
          <p:spPr>
            <a:xfrm>
              <a:off x="5562715" y="8158759"/>
              <a:ext cx="738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12Hr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" name="テキスト ボックス 7">
              <a:extLst>
                <a:ext uri="{FF2B5EF4-FFF2-40B4-BE49-F238E27FC236}">
                  <a16:creationId xmlns:a16="http://schemas.microsoft.com/office/drawing/2014/main" id="{8E17DB80-20AE-4935-8F8E-708986699F9A}"/>
                </a:ext>
              </a:extLst>
            </p:cNvPr>
            <p:cNvSpPr txBox="1"/>
            <p:nvPr/>
          </p:nvSpPr>
          <p:spPr>
            <a:xfrm>
              <a:off x="7279755" y="8158759"/>
              <a:ext cx="738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24Hr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39B6C719-1FEF-43E9-ABD5-437A123DF927}"/>
                </a:ext>
              </a:extLst>
            </p:cNvPr>
            <p:cNvSpPr txBox="1"/>
            <p:nvPr/>
          </p:nvSpPr>
          <p:spPr>
            <a:xfrm>
              <a:off x="8994255" y="8146059"/>
              <a:ext cx="73896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48Hr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" name="テキスト ボックス 9">
              <a:extLst>
                <a:ext uri="{FF2B5EF4-FFF2-40B4-BE49-F238E27FC236}">
                  <a16:creationId xmlns:a16="http://schemas.microsoft.com/office/drawing/2014/main" id="{18223EEB-4ABF-4CAE-86F4-F5DDD5D8673E}"/>
                </a:ext>
              </a:extLst>
            </p:cNvPr>
            <p:cNvSpPr txBox="1"/>
            <p:nvPr/>
          </p:nvSpPr>
          <p:spPr>
            <a:xfrm>
              <a:off x="10416655" y="2526509"/>
              <a:ext cx="12712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-MSCs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" name="テキスト ボックス 10">
              <a:extLst>
                <a:ext uri="{FF2B5EF4-FFF2-40B4-BE49-F238E27FC236}">
                  <a16:creationId xmlns:a16="http://schemas.microsoft.com/office/drawing/2014/main" id="{67E250A5-5B4F-4C7F-A8FB-56C4D8C87BB8}"/>
                </a:ext>
              </a:extLst>
            </p:cNvPr>
            <p:cNvSpPr txBox="1"/>
            <p:nvPr/>
          </p:nvSpPr>
          <p:spPr>
            <a:xfrm>
              <a:off x="10416655" y="2729709"/>
              <a:ext cx="1271278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F-MSCs</a:t>
              </a:r>
              <a:endParaRPr kumimoji="1" lang="ja-JP" altLang="en-US" sz="16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86868505-CAE5-4224-A344-4511AEA638AC}"/>
                </a:ext>
              </a:extLst>
            </p:cNvPr>
            <p:cNvSpPr txBox="1"/>
            <p:nvPr/>
          </p:nvSpPr>
          <p:spPr>
            <a:xfrm rot="16200000">
              <a:off x="-175294" y="5071186"/>
              <a:ext cx="5550774" cy="64633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TGF-β1 in the supernatant</a:t>
              </a:r>
            </a:p>
            <a:p>
              <a:pPr algn="ctr"/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 per 100,000 MSCs in the culture media (</a:t>
              </a:r>
              <a:r>
                <a:rPr lang="en-US" altLang="ja-JP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g</a:t>
              </a:r>
              <a:r>
                <a:rPr lang="en-US" altLang="ja-JP" b="1" dirty="0">
                  <a:latin typeface="Arial" panose="020B0604020202020204" pitchFamily="34" charset="0"/>
                  <a:cs typeface="Arial" panose="020B0604020202020204" pitchFamily="34" charset="0"/>
                </a:rPr>
                <a:t>/ml)</a:t>
              </a:r>
              <a:endParaRPr kumimoji="1" lang="ja-JP" alt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C8192A9C-9C47-404A-A097-D7CD86FBDC70}"/>
              </a:ext>
            </a:extLst>
          </p:cNvPr>
          <p:cNvSpPr txBox="1"/>
          <p:nvPr/>
        </p:nvSpPr>
        <p:spPr>
          <a:xfrm>
            <a:off x="327468" y="404239"/>
            <a:ext cx="26062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8</a:t>
            </a:r>
            <a:endParaRPr kumimoji="1" lang="ja-JP" alt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4800278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54</TotalTime>
  <Words>26</Words>
  <Application>Microsoft Office PowerPoint</Application>
  <PresentationFormat>ユーザー設定</PresentationFormat>
  <Paragraphs>9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n takao</dc:creator>
  <cp:lastModifiedBy>NAKASHIMA Taku</cp:lastModifiedBy>
  <cp:revision>48</cp:revision>
  <dcterms:created xsi:type="dcterms:W3CDTF">2021-03-08T06:18:33Z</dcterms:created>
  <dcterms:modified xsi:type="dcterms:W3CDTF">2021-07-24T08:05:44Z</dcterms:modified>
</cp:coreProperties>
</file>